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0064B-98AB-4524-9DC3-B430310D30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74D28-49E7-4E98-B357-EA0B4CDD4A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23B9D-0B3A-478F-941A-F62016E92F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C048A-CD1E-4E8E-91AC-D01DE7D0C8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DFD67-E4C8-47BA-AFE9-A0E11A66A2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7E60E-0325-4615-AC2C-6AA021E328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42C78-989B-41DA-8708-0A1D44F992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E57F5-B4C5-4254-9D75-F21E29922A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C3006-793D-4370-AD64-060F776386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29090-A4E0-46D5-942C-F7D6D8AFBD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39467-8110-4CDF-8580-AD7DE1173D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B3BC0-F96F-4729-BB84-5CCF2EDFC4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1E843F-C65C-454F-B769-BA15ADD6F18D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1"/>
          <p:cNvSpPr/>
          <p:nvPr/>
        </p:nvSpPr>
        <p:spPr>
          <a:xfrm>
            <a:off x="647640" y="4357800"/>
            <a:ext cx="55054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: Effect of QUA2-1 and PME3 mutations on plant biomas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esh weight (FW) of aerial vegetative portion of plants and dry weight (DW/FW) ratio were calculated. Data represent the average ± SD of at least six plants. Asterisks indicate statistically significant differences between mutants and the wild type according to Student’s t-test (p&lt;0.05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13000" y="2055960"/>
          <a:ext cx="3456000" cy="1558800"/>
        </p:xfrm>
        <a:graphic>
          <a:graphicData uri="http://schemas.openxmlformats.org/drawingml/2006/table">
            <a:tbl>
              <a:tblPr/>
              <a:tblGrid>
                <a:gridCol w="1152360"/>
                <a:gridCol w="1150920"/>
                <a:gridCol w="1152720"/>
              </a:tblGrid>
              <a:tr h="388800"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 (mg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W/FW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0600"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T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8 ± 2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0 ± 0.00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0600"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me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0 ± 3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2 ± 0.00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8800"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ua2-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</a:t>
                      </a: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2 ± 50 *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9680" bIns="496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17 ± 0.00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9T23:56:23Z</dcterms:created>
  <dc:creator>Utenti</dc:creator>
  <dc:description/>
  <dc:language>en-US</dc:language>
  <cp:lastModifiedBy>Daniela Bellincampi</cp:lastModifiedBy>
  <cp:lastPrinted>2013-07-05T13:42:32Z</cp:lastPrinted>
  <dcterms:modified xsi:type="dcterms:W3CDTF">2013-07-31T14:42:35Z</dcterms:modified>
  <cp:revision>286</cp:revision>
  <dc:subject/>
  <dc:title>Diapositiva 1</dc:title>
</cp:coreProperties>
</file>